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1B7F6-E938-4C0C-BEBA-FF40F93A2A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2D2BA-08C3-4C70-AD77-EC9C1CE57A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E28C1-A6F1-49D5-BB14-E3F9626E7B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E47C5-1F7D-478B-85F7-A020E5C13C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200F4-3046-44B3-A8B4-4D0A55EE95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02D5A-3129-4360-81AB-B3F70D302A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16DADF-6F01-44E0-BD3D-FD1FDA4932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B3201-001D-4963-919F-EEADB46BBD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64E59-AF5D-4925-AFE3-B1962F7857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D513B-BF3F-44E6-BA56-294D1CF737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1795B-36F4-4DCD-A95F-AD91684EF1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7CD61-8EF1-4A18-A1AD-DF9F43EE8C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712E82-459C-4625-AFB4-3777378856F0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5449" b="0"/>
          <a:stretch/>
        </p:blipFill>
        <p:spPr>
          <a:xfrm>
            <a:off x="266760" y="108000"/>
            <a:ext cx="2822400" cy="35701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7265" b="0"/>
          <a:stretch/>
        </p:blipFill>
        <p:spPr>
          <a:xfrm>
            <a:off x="2997360" y="328680"/>
            <a:ext cx="2857320" cy="30938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0" t="0" r="5362" b="0"/>
          <a:stretch/>
        </p:blipFill>
        <p:spPr>
          <a:xfrm>
            <a:off x="6073920" y="546120"/>
            <a:ext cx="2938320" cy="2859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 flipH="1">
            <a:off x="1287000" y="901800"/>
            <a:ext cx="203400" cy="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H="1">
            <a:off x="5064120" y="1552680"/>
            <a:ext cx="203040" cy="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8013240" y="1635120"/>
            <a:ext cx="203400" cy="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171880" y="93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186520" y="63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556840" y="50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79320" y="4040280"/>
            <a:ext cx="2308320" cy="21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Epsilonproteobacteria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0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Epsilonproteobacteria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0.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Epsilonproteobacteria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0.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Epsilonproteobacteria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0000"/>
                </a:solidFill>
                <a:latin typeface="Arial"/>
              </a:rPr>
              <a:t>0.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…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4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5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…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02080" y="3538440"/>
            <a:ext cx="2922480" cy="31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0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Gammaproteobacteria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0.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Gammaproteobacteria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0.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…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5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5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verage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 </a:t>
            </a: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lphaproteobacteria: 0.2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372360" y="3664080"/>
            <a:ext cx="259848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Gammaproteobacteria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0.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Deltaproteobacteria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ff3399"/>
                </a:solidFill>
                <a:latin typeface="Arial"/>
              </a:rPr>
              <a:t>0.2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Actinobacteria</a:t>
            </a: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0.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Betaproteobacteria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d4d434"/>
                </a:solidFill>
                <a:latin typeface="Arial"/>
              </a:rPr>
              <a:t>0.4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Gammaproteobacteria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cc33"/>
                </a:solidFill>
                <a:latin typeface="Arial"/>
              </a:rPr>
              <a:t>0.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Alphaproteobacteria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	</a:t>
            </a:r>
            <a:r>
              <a:rPr b="1" lang="es-ES" sz="1200" spc="-1" strike="noStrike">
                <a:solidFill>
                  <a:srgbClr val="3366ff"/>
                </a:solidFill>
                <a:latin typeface="Arial"/>
              </a:rPr>
              <a:t>0.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2T16:43:09Z</dcterms:created>
  <dc:creator>Javier</dc:creator>
  <dc:description/>
  <dc:language>en-US</dc:language>
  <cp:lastModifiedBy>heatherw</cp:lastModifiedBy>
  <dcterms:modified xsi:type="dcterms:W3CDTF">2008-04-16T10:01:34Z</dcterms:modified>
  <cp:revision>3</cp:revision>
  <dc:subject/>
  <dc:title>Diapositiva 1</dc:title>
</cp:coreProperties>
</file>